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7" r:id="rId2"/>
    <p:sldId id="260" r:id="rId3"/>
    <p:sldId id="262" r:id="rId4"/>
    <p:sldId id="263" r:id="rId5"/>
    <p:sldId id="264" r:id="rId6"/>
    <p:sldId id="265" r:id="rId7"/>
    <p:sldId id="266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405" autoAdjust="0"/>
    <p:restoredTop sz="94422"/>
  </p:normalViewPr>
  <p:slideViewPr>
    <p:cSldViewPr snapToGrid="0">
      <p:cViewPr varScale="1">
        <p:scale>
          <a:sx n="82" d="100"/>
          <a:sy n="82" d="100"/>
        </p:scale>
        <p:origin x="653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960F8F-1CC2-2F49-9500-691511EFA74D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EB1E19-3630-7D46-945A-9658248ED9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01260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EB1E19-3630-7D46-945A-9658248ED92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35618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EB1E19-3630-7D46-945A-9658248ED92B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2617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00BEDB-4287-24A0-11B7-8DECEBE0ED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665578C-54B8-C8D9-141E-BDB2393D57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7A99141-A9BF-CB36-717E-71319B997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F9B9D47-CEA0-CAE7-7438-23F1DD826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4058E6-3360-761F-0BBF-EB5858275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0751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37947E-FEA2-F27C-AD5C-96DD0C4E37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6B0CDB7-014E-236A-BF95-6634AF6CDF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8D8794-322D-06F6-7DB5-00C1CB6AAA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D7C57E-3BF7-D60A-9426-0F640A8E5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1A641A-2C95-3DE5-C641-2359F524E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288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268543D-1E24-8C58-A2DB-2B2A902EC5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E057687-4F1C-2454-591A-3F4A15BFA6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F5FF8AB-30A7-430E-D04E-EB7714473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B98E76-8E08-78A1-BE1B-33FD22B5B3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10516D-D385-C5CA-AEDD-2A0CD402A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3625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DCADEA-BE4B-6CBF-474E-F841DE08B2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3A82846-1431-5B38-1625-26A557A3AF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0DCF7A-D1F2-6B24-EE8E-1BB7C92E0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6A8937-407A-A60E-F0E4-0681B3F0B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3E3CA3F-5536-B6D0-0189-142E4D3CE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9804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ADABA7-5ACF-2241-C9CE-BFBEE28934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41E472E-A39E-954E-5478-441DC13782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694B81F-5613-7738-C98F-C7B5CE123D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4D3E7A-9A4C-222E-3E71-B682C784F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71AD14-34D3-7C20-C61B-9214E6587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868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419BBF-6316-E233-67E0-C07A9B91A7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DE98F6A-4258-9F61-5E3E-3C9214BC44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1F0D0E7-30E9-618B-6C5E-8886D12249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77F05EF-F579-9DAA-1B8A-F98F7B31F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C2D12A8-3FEF-D712-8B95-8CE0ED316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C0B5E25-62E0-2C37-BA14-3838EF9998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3688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856A16-F613-16C3-A24C-AE8657241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92A3D5-31D1-03FC-06A8-BEA891E11D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128B7FC-FF21-71B2-ACA9-AF9A649867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1DDC32B-8567-F46E-AED7-7830CE2DC2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2DF9FB7-CF1C-CD3C-6142-3377423DB5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3BDF4D1-5434-93C9-2337-262730328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191E880-31D3-90C3-569D-73BF86EC6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5A8867A-4469-2F08-159C-F1FE5DCB2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8821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E1CAAD-E9BC-EBB0-C68C-A396D6E45B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DF23301-546E-D9D6-5C74-7A5F31AD8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D81B69F-DD9D-4768-92D5-F5C04F5C1F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6450D5C-6D89-B34F-5C48-90C624662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1471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5B4C1FD-B4FC-829A-C982-33BB655E5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A86A45F-E8E8-A62C-545F-F08FDB061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50D4881-BF80-877B-B895-17F9B92421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0787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21993A-9D82-B0EB-4662-810423B352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980E32F-E4EC-BBB7-25C9-B2AC187C34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7765BC2-E2C7-64DF-DBCD-A79060DF16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412018C-967A-14E8-06C1-91752F9999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EB19043-82C3-57C4-CA4D-0F78C771F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BDE9EC-7A4E-92A7-366D-BBA07A5F0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4206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70A4E6-7DCB-FC0F-C2D6-53512E0326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C6F3B21-4AAE-6FFE-B832-4DFE155F73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D3D4035-62FB-00BF-35F2-0A079BFAAD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156364C-DC05-9D40-363E-7AE357596C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2788B5C-76B2-06F4-7B93-42E7482C0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3219005-2BB5-4AEE-2251-77E88B9DF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4681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8B9A5BF-2AE1-E15D-357F-E8EE3153DC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1408653-D98E-66D6-8644-98135CA1E0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5C8756-43A0-F004-A0B5-ACD3F121AA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6F37A3-7052-924C-BDF2-89973430A87F}" type="datetimeFigureOut">
              <a:rPr kumimoji="1" lang="ja-JP" altLang="en-US" smtClean="0"/>
              <a:t>2023/12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59E46C-40AD-1038-E880-8615956805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655409-ED38-034F-8510-966F357FCB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D69885-7C46-C54D-A33F-AB8D8062F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781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7" Type="http://schemas.openxmlformats.org/officeDocument/2006/relationships/image" Target="../media/image2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emf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emf"/><Relationship Id="rId5" Type="http://schemas.openxmlformats.org/officeDocument/2006/relationships/image" Target="../media/image27.emf"/><Relationship Id="rId4" Type="http://schemas.openxmlformats.org/officeDocument/2006/relationships/image" Target="../media/image2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emf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C9D316E-218D-D4DF-ACB9-17D059D3DC4B}"/>
              </a:ext>
            </a:extLst>
          </p:cNvPr>
          <p:cNvSpPr txBox="1"/>
          <p:nvPr/>
        </p:nvSpPr>
        <p:spPr>
          <a:xfrm>
            <a:off x="-4975" y="-435"/>
            <a:ext cx="12570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.</a:t>
            </a:r>
          </a:p>
          <a:p>
            <a:r>
              <a:rPr kumimoji="1" lang="en-US" altLang="ja-JP" dirty="0"/>
              <a:t>Figure S1.</a:t>
            </a:r>
            <a:endParaRPr kumimoji="1" lang="ja-JP" altLang="en-US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5B89ED9B-5CD2-B54A-D131-D043DB832B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7612" y="0"/>
            <a:ext cx="2478299" cy="1635956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7193CC8D-A8E6-EB47-767A-A970482296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52252" y="1733719"/>
            <a:ext cx="2471339" cy="1642918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6E259E85-DBC6-CB8C-3233-2320552614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49932" y="3474400"/>
            <a:ext cx="2478300" cy="164291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1A5E8217-ED3B-B680-B292-F8960496B9E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52252" y="5215082"/>
            <a:ext cx="2478300" cy="1642918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921CAD20-BA3E-DBEC-8C31-6E490B592A6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60283" y="0"/>
            <a:ext cx="2478299" cy="1635956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450220BF-1BA7-7302-E69F-0BAAF797AC5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67243" y="1733719"/>
            <a:ext cx="2471339" cy="164291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2421C1A0-26CE-F6C5-E010-0D956FC2A22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60282" y="3474400"/>
            <a:ext cx="2478300" cy="1642918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0EC64E6-DD3D-3D16-9968-C5E3D76BB1D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60282" y="5215082"/>
            <a:ext cx="2478300" cy="1642918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A507AFF1-B1CC-3A2B-37D2-25FAEB26B2E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978085" y="0"/>
            <a:ext cx="2478299" cy="1635956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F1822E12-0EAA-7D36-0869-4B3456A4975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985045" y="1733719"/>
            <a:ext cx="2471339" cy="1642918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E675BA37-9288-3505-CF19-ECBBCC2D357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978084" y="3474400"/>
            <a:ext cx="2478300" cy="1642918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3F3E3203-90BC-6751-D1AE-E1E35872895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978084" y="5215082"/>
            <a:ext cx="2478300" cy="1642918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B755A70-DFA8-21CF-657E-5975A465BE8B}"/>
              </a:ext>
            </a:extLst>
          </p:cNvPr>
          <p:cNvSpPr txBox="1"/>
          <p:nvPr/>
        </p:nvSpPr>
        <p:spPr>
          <a:xfrm>
            <a:off x="1004248" y="0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A</a:t>
            </a:r>
            <a:endParaRPr kumimoji="1" lang="ja-JP" altLang="en-US" b="1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E446F82-B7FC-7833-4FCB-52A0BCFDF9DD}"/>
              </a:ext>
            </a:extLst>
          </p:cNvPr>
          <p:cNvSpPr txBox="1"/>
          <p:nvPr/>
        </p:nvSpPr>
        <p:spPr>
          <a:xfrm>
            <a:off x="3823879" y="0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B</a:t>
            </a:r>
            <a:endParaRPr kumimoji="1" lang="ja-JP" altLang="en-US" b="1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3B52F9E-A0AC-67C3-D7F8-346E68227679}"/>
              </a:ext>
            </a:extLst>
          </p:cNvPr>
          <p:cNvSpPr txBox="1"/>
          <p:nvPr/>
        </p:nvSpPr>
        <p:spPr>
          <a:xfrm>
            <a:off x="6634720" y="0"/>
            <a:ext cx="34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C</a:t>
            </a:r>
            <a:endParaRPr kumimoji="1" lang="ja-JP" altLang="en-US" b="1"/>
          </a:p>
        </p:txBody>
      </p: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48C3EF43-F599-F26A-1D7B-829ACF3B2584}"/>
              </a:ext>
            </a:extLst>
          </p:cNvPr>
          <p:cNvGrpSpPr/>
          <p:nvPr/>
        </p:nvGrpSpPr>
        <p:grpSpPr>
          <a:xfrm>
            <a:off x="1640713" y="1454177"/>
            <a:ext cx="2131585" cy="145016"/>
            <a:chOff x="2051531" y="1454177"/>
            <a:chExt cx="2131585" cy="145016"/>
          </a:xfrm>
        </p:grpSpPr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DBA6CBAE-5162-9D5B-5D15-040DECF93018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133DCA34-C9A6-5E40-A18A-02019492BD36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D4628D33-D338-750F-5F5E-F9DBE006AA29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D334EFE0-95B6-2DEA-328B-8C2A0913417E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AF950E86-8781-5AA0-D8A1-24A0324CE17D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7982C833-AA46-2C8E-37C4-4536918DF2D8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0CE592DE-49E7-7BAC-F650-3B93D3BEE8B0}"/>
              </a:ext>
            </a:extLst>
          </p:cNvPr>
          <p:cNvGrpSpPr/>
          <p:nvPr/>
        </p:nvGrpSpPr>
        <p:grpSpPr>
          <a:xfrm>
            <a:off x="1636520" y="3200248"/>
            <a:ext cx="2131585" cy="145016"/>
            <a:chOff x="2051531" y="1454177"/>
            <a:chExt cx="2131585" cy="145016"/>
          </a:xfrm>
        </p:grpSpPr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229FF398-56E4-B994-9707-6B22A90B8897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18737695-37E2-A759-AEF0-4F34322491F7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B18C0E23-0CBC-3894-E710-0594EBABCD32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C33B0E25-D539-53CC-59EC-73F1D15A1074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20CD0211-8B20-2D8D-234F-155E7819096B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65EFEB56-51F7-2CD2-EFF9-BD998CD3B18C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CDF5CE7F-9277-2630-D09A-FBDFD4EE85C8}"/>
              </a:ext>
            </a:extLst>
          </p:cNvPr>
          <p:cNvGrpSpPr/>
          <p:nvPr/>
        </p:nvGrpSpPr>
        <p:grpSpPr>
          <a:xfrm>
            <a:off x="1636520" y="4935939"/>
            <a:ext cx="2131585" cy="145016"/>
            <a:chOff x="2051531" y="1454177"/>
            <a:chExt cx="2131585" cy="145016"/>
          </a:xfrm>
        </p:grpSpPr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40AF6F0C-247E-842A-E488-8FD71CD1F77F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32283E91-02D6-6096-4457-B195D1DE4FC6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2389D55E-BCBF-018F-EB99-F0C0BFBF1E60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A7AA3721-5BC5-96EF-3190-A9C5E57D34EA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E26FDDEB-BE8D-2D7C-F809-3F7E76B49000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21F37768-30A2-9887-85F3-39A079D18D15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13B2CABB-9DA5-39A5-FEC3-5A515FCBFBAF}"/>
              </a:ext>
            </a:extLst>
          </p:cNvPr>
          <p:cNvGrpSpPr/>
          <p:nvPr/>
        </p:nvGrpSpPr>
        <p:grpSpPr>
          <a:xfrm>
            <a:off x="1659929" y="6676952"/>
            <a:ext cx="2131585" cy="145016"/>
            <a:chOff x="2051531" y="1454177"/>
            <a:chExt cx="2131585" cy="145016"/>
          </a:xfrm>
        </p:grpSpPr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9B323818-7BA1-3AB4-2DA1-2A932B66C56D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BC82CE37-7BBB-F380-8B62-59573870A101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F4FE5F6D-9032-66D3-5B56-158EA4AFA255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69612874-01DC-71AE-F4AD-04F586BF5736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943DAE79-9C98-1094-75F5-EE16D4045ECD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637992DF-D50F-939D-89ED-4E70D756C92B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6DF0C82F-E9CD-03F5-C321-F0B22E6469D5}"/>
              </a:ext>
            </a:extLst>
          </p:cNvPr>
          <p:cNvGrpSpPr/>
          <p:nvPr/>
        </p:nvGrpSpPr>
        <p:grpSpPr>
          <a:xfrm>
            <a:off x="4460365" y="1454177"/>
            <a:ext cx="2131585" cy="145016"/>
            <a:chOff x="2051531" y="1454177"/>
            <a:chExt cx="2131585" cy="145016"/>
          </a:xfrm>
        </p:grpSpPr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F119E73F-6232-F93A-5C3D-A0FD7754C9C4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FEC6E615-5BED-6A7C-89FC-F0D5899DABB2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20855F6E-FC89-2169-BFBC-A5C5DB401FDD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539BEB4A-6EBD-91C9-CF29-A8C502ADB00A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11BCFE2D-8A4E-A121-C00E-87F879F2CA1D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5BF6FC79-2B22-13E5-F8EA-9648DBE21F7A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5780902B-A6FC-BC0F-C58B-A8AC5EABF4C6}"/>
              </a:ext>
            </a:extLst>
          </p:cNvPr>
          <p:cNvGrpSpPr/>
          <p:nvPr/>
        </p:nvGrpSpPr>
        <p:grpSpPr>
          <a:xfrm>
            <a:off x="4456172" y="3200248"/>
            <a:ext cx="2131585" cy="145016"/>
            <a:chOff x="2051531" y="1454177"/>
            <a:chExt cx="2131585" cy="145016"/>
          </a:xfrm>
        </p:grpSpPr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FEC94FFF-916C-2A3D-213D-457AC221EC50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181DCA93-FC4E-37AE-7D1B-4082F88BAC7F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DDE6B4C8-1011-B395-D25D-0A26BC520B77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74AF33DD-442E-D90E-B611-BAFE14220BBE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48144197-F01B-9580-138F-835AEC7DAC78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BAD3B3F9-F4E2-F6E1-4E2F-CA61391E0D90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AD32ED5C-D7D9-CDED-907C-83CAE96741A8}"/>
              </a:ext>
            </a:extLst>
          </p:cNvPr>
          <p:cNvGrpSpPr/>
          <p:nvPr/>
        </p:nvGrpSpPr>
        <p:grpSpPr>
          <a:xfrm>
            <a:off x="4456172" y="4935939"/>
            <a:ext cx="2131585" cy="145016"/>
            <a:chOff x="2051531" y="1454177"/>
            <a:chExt cx="2131585" cy="145016"/>
          </a:xfrm>
        </p:grpSpPr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8DE2809E-4BBE-ECD4-6481-B28D1CA78DDA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9DD999F4-ADCF-DD2A-4053-A9A368678609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2DFFB7AB-7618-D7E3-BFE4-5592B7013B92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9F0DC0A3-8515-C95F-F7A7-E8DF5DA7900C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AE377967-9192-8BF8-524B-F86085791BD7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19FEEA10-6270-FE2A-6B40-26F9E28EBBFA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id="{5839F52E-C507-9975-7475-F630613BDDD0}"/>
              </a:ext>
            </a:extLst>
          </p:cNvPr>
          <p:cNvGrpSpPr/>
          <p:nvPr/>
        </p:nvGrpSpPr>
        <p:grpSpPr>
          <a:xfrm>
            <a:off x="4479581" y="6676952"/>
            <a:ext cx="2131585" cy="145016"/>
            <a:chOff x="2051531" y="1454177"/>
            <a:chExt cx="2131585" cy="145016"/>
          </a:xfrm>
        </p:grpSpPr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7ABB9F9A-9663-17D1-48FA-65B50AD25CC6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9E4FBD8A-B2D6-96D6-0EA6-E2D8C1CFB15E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A780F5D5-DC45-CB9B-A57D-768774E51691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4F4F636C-6FC4-7031-9376-DEC9C7F4D23F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91BA525D-1478-5608-697A-49ED35791B0A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1C717C0C-2831-094D-E603-A543AC31BE8E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0F083794-A339-76E3-EC0D-A9AEB3B2026C}"/>
              </a:ext>
            </a:extLst>
          </p:cNvPr>
          <p:cNvGrpSpPr/>
          <p:nvPr/>
        </p:nvGrpSpPr>
        <p:grpSpPr>
          <a:xfrm>
            <a:off x="7289810" y="1454177"/>
            <a:ext cx="2131585" cy="145016"/>
            <a:chOff x="2051531" y="1454177"/>
            <a:chExt cx="2131585" cy="145016"/>
          </a:xfrm>
        </p:grpSpPr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2F7E6991-E1CE-9A50-D61A-1811D87FBEC1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9B5E8CA3-7C1C-C436-5C93-BF186E3F7B3C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D0E27EE0-4C5E-4912-3A1F-9AD7BA9FAAE6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0015C864-3B46-1D00-E2B6-1A8C8D9BF6DB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F2724D35-8455-57E9-7B65-65768005D4DF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ACD85FC1-3ED3-7217-34F4-8966183398A4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grpSp>
        <p:nvGrpSpPr>
          <p:cNvPr id="84" name="グループ化 83">
            <a:extLst>
              <a:ext uri="{FF2B5EF4-FFF2-40B4-BE49-F238E27FC236}">
                <a16:creationId xmlns:a16="http://schemas.microsoft.com/office/drawing/2014/main" id="{5FACEBFB-FB6F-F3B2-3792-00AFDF430AA8}"/>
              </a:ext>
            </a:extLst>
          </p:cNvPr>
          <p:cNvGrpSpPr/>
          <p:nvPr/>
        </p:nvGrpSpPr>
        <p:grpSpPr>
          <a:xfrm>
            <a:off x="7285617" y="3200248"/>
            <a:ext cx="2131585" cy="145016"/>
            <a:chOff x="2051531" y="1454177"/>
            <a:chExt cx="2131585" cy="145016"/>
          </a:xfrm>
        </p:grpSpPr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2FAAC33F-4E55-38DA-8BCF-375918B64ECA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86" name="正方形/長方形 85">
              <a:extLst>
                <a:ext uri="{FF2B5EF4-FFF2-40B4-BE49-F238E27FC236}">
                  <a16:creationId xmlns:a16="http://schemas.microsoft.com/office/drawing/2014/main" id="{970B0B17-F998-CB7A-9F6C-18126FB52E81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87" name="正方形/長方形 86">
              <a:extLst>
                <a:ext uri="{FF2B5EF4-FFF2-40B4-BE49-F238E27FC236}">
                  <a16:creationId xmlns:a16="http://schemas.microsoft.com/office/drawing/2014/main" id="{FE384D52-A3D8-19F2-3DDD-5BD0C9BF0CCB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88" name="正方形/長方形 87">
              <a:extLst>
                <a:ext uri="{FF2B5EF4-FFF2-40B4-BE49-F238E27FC236}">
                  <a16:creationId xmlns:a16="http://schemas.microsoft.com/office/drawing/2014/main" id="{E0CF9607-07F0-A60D-A71B-41924CBC51F0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89" name="正方形/長方形 88">
              <a:extLst>
                <a:ext uri="{FF2B5EF4-FFF2-40B4-BE49-F238E27FC236}">
                  <a16:creationId xmlns:a16="http://schemas.microsoft.com/office/drawing/2014/main" id="{4020D362-91C8-42EF-7787-A1035C6A4CD5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90" name="正方形/長方形 89">
              <a:extLst>
                <a:ext uri="{FF2B5EF4-FFF2-40B4-BE49-F238E27FC236}">
                  <a16:creationId xmlns:a16="http://schemas.microsoft.com/office/drawing/2014/main" id="{6BD23F73-5EC9-3140-48E8-567E5274827F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id="{ECFCE123-F3C1-B518-0AA9-291D2ABA1654}"/>
              </a:ext>
            </a:extLst>
          </p:cNvPr>
          <p:cNvGrpSpPr/>
          <p:nvPr/>
        </p:nvGrpSpPr>
        <p:grpSpPr>
          <a:xfrm>
            <a:off x="7285617" y="4935939"/>
            <a:ext cx="2131585" cy="145016"/>
            <a:chOff x="2051531" y="1454177"/>
            <a:chExt cx="2131585" cy="145016"/>
          </a:xfrm>
        </p:grpSpPr>
        <p:sp>
          <p:nvSpPr>
            <p:cNvPr id="92" name="正方形/長方形 91">
              <a:extLst>
                <a:ext uri="{FF2B5EF4-FFF2-40B4-BE49-F238E27FC236}">
                  <a16:creationId xmlns:a16="http://schemas.microsoft.com/office/drawing/2014/main" id="{9E4F6EF2-672D-DB49-313B-3D9BC50666CE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93" name="正方形/長方形 92">
              <a:extLst>
                <a:ext uri="{FF2B5EF4-FFF2-40B4-BE49-F238E27FC236}">
                  <a16:creationId xmlns:a16="http://schemas.microsoft.com/office/drawing/2014/main" id="{7F44870F-AA58-1784-62C7-3819149A9D72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94" name="正方形/長方形 93">
              <a:extLst>
                <a:ext uri="{FF2B5EF4-FFF2-40B4-BE49-F238E27FC236}">
                  <a16:creationId xmlns:a16="http://schemas.microsoft.com/office/drawing/2014/main" id="{A3AA406F-7F15-6A3D-60B8-831CB3D1EEFE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95" name="正方形/長方形 94">
              <a:extLst>
                <a:ext uri="{FF2B5EF4-FFF2-40B4-BE49-F238E27FC236}">
                  <a16:creationId xmlns:a16="http://schemas.microsoft.com/office/drawing/2014/main" id="{DED30D46-A757-34D8-05CA-68B6A4BED64B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96" name="正方形/長方形 95">
              <a:extLst>
                <a:ext uri="{FF2B5EF4-FFF2-40B4-BE49-F238E27FC236}">
                  <a16:creationId xmlns:a16="http://schemas.microsoft.com/office/drawing/2014/main" id="{249CA186-3324-75A8-8F07-C41CC94013FB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97" name="正方形/長方形 96">
              <a:extLst>
                <a:ext uri="{FF2B5EF4-FFF2-40B4-BE49-F238E27FC236}">
                  <a16:creationId xmlns:a16="http://schemas.microsoft.com/office/drawing/2014/main" id="{84597E59-5FC9-B1EC-E89B-8E341F3B7467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grpSp>
        <p:nvGrpSpPr>
          <p:cNvPr id="98" name="グループ化 97">
            <a:extLst>
              <a:ext uri="{FF2B5EF4-FFF2-40B4-BE49-F238E27FC236}">
                <a16:creationId xmlns:a16="http://schemas.microsoft.com/office/drawing/2014/main" id="{2D32A0EE-D0E1-7DE1-3651-65753D3A9479}"/>
              </a:ext>
            </a:extLst>
          </p:cNvPr>
          <p:cNvGrpSpPr/>
          <p:nvPr/>
        </p:nvGrpSpPr>
        <p:grpSpPr>
          <a:xfrm>
            <a:off x="7309026" y="6676952"/>
            <a:ext cx="2131585" cy="145016"/>
            <a:chOff x="2051531" y="1454177"/>
            <a:chExt cx="2131585" cy="145016"/>
          </a:xfrm>
        </p:grpSpPr>
        <p:sp>
          <p:nvSpPr>
            <p:cNvPr id="99" name="正方形/長方形 98">
              <a:extLst>
                <a:ext uri="{FF2B5EF4-FFF2-40B4-BE49-F238E27FC236}">
                  <a16:creationId xmlns:a16="http://schemas.microsoft.com/office/drawing/2014/main" id="{69F0A08C-CEF8-E1AC-C894-BD64DA0C55D4}"/>
                </a:ext>
              </a:extLst>
            </p:cNvPr>
            <p:cNvSpPr/>
            <p:nvPr/>
          </p:nvSpPr>
          <p:spPr>
            <a:xfrm>
              <a:off x="2051531" y="1454177"/>
              <a:ext cx="268124" cy="145016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100" name="正方形/長方形 99">
              <a:extLst>
                <a:ext uri="{FF2B5EF4-FFF2-40B4-BE49-F238E27FC236}">
                  <a16:creationId xmlns:a16="http://schemas.microsoft.com/office/drawing/2014/main" id="{EE515708-A9B2-9CAA-F117-1B0BA8B9DED5}"/>
                </a:ext>
              </a:extLst>
            </p:cNvPr>
            <p:cNvSpPr/>
            <p:nvPr/>
          </p:nvSpPr>
          <p:spPr>
            <a:xfrm>
              <a:off x="2319654" y="1454177"/>
              <a:ext cx="359733" cy="14501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101" name="正方形/長方形 100">
              <a:extLst>
                <a:ext uri="{FF2B5EF4-FFF2-40B4-BE49-F238E27FC236}">
                  <a16:creationId xmlns:a16="http://schemas.microsoft.com/office/drawing/2014/main" id="{FED6A0B6-0550-A223-759E-7B57FBAEB6F7}"/>
                </a:ext>
              </a:extLst>
            </p:cNvPr>
            <p:cNvSpPr/>
            <p:nvPr/>
          </p:nvSpPr>
          <p:spPr>
            <a:xfrm>
              <a:off x="2679386" y="1454177"/>
              <a:ext cx="500499" cy="145016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102" name="正方形/長方形 101">
              <a:extLst>
                <a:ext uri="{FF2B5EF4-FFF2-40B4-BE49-F238E27FC236}">
                  <a16:creationId xmlns:a16="http://schemas.microsoft.com/office/drawing/2014/main" id="{D63C512D-46C0-07BB-0DFF-927696326BE5}"/>
                </a:ext>
              </a:extLst>
            </p:cNvPr>
            <p:cNvSpPr/>
            <p:nvPr/>
          </p:nvSpPr>
          <p:spPr>
            <a:xfrm>
              <a:off x="3179885" y="1454177"/>
              <a:ext cx="337390" cy="14501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103" name="正方形/長方形 102">
              <a:extLst>
                <a:ext uri="{FF2B5EF4-FFF2-40B4-BE49-F238E27FC236}">
                  <a16:creationId xmlns:a16="http://schemas.microsoft.com/office/drawing/2014/main" id="{0DE274F6-E5DD-CD81-66A6-2FEA5E0961AB}"/>
                </a:ext>
              </a:extLst>
            </p:cNvPr>
            <p:cNvSpPr/>
            <p:nvPr/>
          </p:nvSpPr>
          <p:spPr>
            <a:xfrm>
              <a:off x="3517494" y="1454177"/>
              <a:ext cx="375155" cy="14501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  <p:sp>
          <p:nvSpPr>
            <p:cNvPr id="104" name="正方形/長方形 103">
              <a:extLst>
                <a:ext uri="{FF2B5EF4-FFF2-40B4-BE49-F238E27FC236}">
                  <a16:creationId xmlns:a16="http://schemas.microsoft.com/office/drawing/2014/main" id="{EC7C1B60-9020-6BDA-BAA2-9ED12AE4C696}"/>
                </a:ext>
              </a:extLst>
            </p:cNvPr>
            <p:cNvSpPr/>
            <p:nvPr/>
          </p:nvSpPr>
          <p:spPr>
            <a:xfrm>
              <a:off x="3892648" y="1454177"/>
              <a:ext cx="290468" cy="145016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300" b="1"/>
            </a:p>
          </p:txBody>
        </p:sp>
      </p:grpSp>
      <p:sp>
        <p:nvSpPr>
          <p:cNvPr id="105" name="正方形/長方形 104">
            <a:extLst>
              <a:ext uri="{FF2B5EF4-FFF2-40B4-BE49-F238E27FC236}">
                <a16:creationId xmlns:a16="http://schemas.microsoft.com/office/drawing/2014/main" id="{3C604C6E-59DD-27A1-C9A5-6DDCD48F632C}"/>
              </a:ext>
            </a:extLst>
          </p:cNvPr>
          <p:cNvSpPr/>
          <p:nvPr/>
        </p:nvSpPr>
        <p:spPr>
          <a:xfrm>
            <a:off x="9802847" y="2609626"/>
            <a:ext cx="704922" cy="279542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/>
              <a:t>2013</a:t>
            </a:r>
          </a:p>
        </p:txBody>
      </p:sp>
      <p:sp>
        <p:nvSpPr>
          <p:cNvPr id="106" name="正方形/長方形 105">
            <a:extLst>
              <a:ext uri="{FF2B5EF4-FFF2-40B4-BE49-F238E27FC236}">
                <a16:creationId xmlns:a16="http://schemas.microsoft.com/office/drawing/2014/main" id="{12F7190E-DE42-CAE1-22BD-4EE960ABE7D9}"/>
              </a:ext>
            </a:extLst>
          </p:cNvPr>
          <p:cNvSpPr/>
          <p:nvPr/>
        </p:nvSpPr>
        <p:spPr>
          <a:xfrm>
            <a:off x="9802847" y="2889168"/>
            <a:ext cx="704922" cy="279542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/>
              <a:t>2014</a:t>
            </a:r>
          </a:p>
        </p:txBody>
      </p:sp>
      <p:sp>
        <p:nvSpPr>
          <p:cNvPr id="107" name="正方形/長方形 106">
            <a:extLst>
              <a:ext uri="{FF2B5EF4-FFF2-40B4-BE49-F238E27FC236}">
                <a16:creationId xmlns:a16="http://schemas.microsoft.com/office/drawing/2014/main" id="{2154D69B-FA3B-B4D4-21D0-40FD7DB97861}"/>
              </a:ext>
            </a:extLst>
          </p:cNvPr>
          <p:cNvSpPr/>
          <p:nvPr/>
        </p:nvSpPr>
        <p:spPr>
          <a:xfrm>
            <a:off x="9802847" y="3168710"/>
            <a:ext cx="704922" cy="279542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/>
              <a:t>2015</a:t>
            </a:r>
          </a:p>
        </p:txBody>
      </p:sp>
      <p:sp>
        <p:nvSpPr>
          <p:cNvPr id="108" name="正方形/長方形 107">
            <a:extLst>
              <a:ext uri="{FF2B5EF4-FFF2-40B4-BE49-F238E27FC236}">
                <a16:creationId xmlns:a16="http://schemas.microsoft.com/office/drawing/2014/main" id="{4D031D39-FD4A-8919-1FB0-BAD31A62CE37}"/>
              </a:ext>
            </a:extLst>
          </p:cNvPr>
          <p:cNvSpPr/>
          <p:nvPr/>
        </p:nvSpPr>
        <p:spPr>
          <a:xfrm>
            <a:off x="9802847" y="3439030"/>
            <a:ext cx="704922" cy="279542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/>
              <a:t>2016</a:t>
            </a:r>
          </a:p>
        </p:txBody>
      </p:sp>
      <p:sp>
        <p:nvSpPr>
          <p:cNvPr id="109" name="正方形/長方形 108">
            <a:extLst>
              <a:ext uri="{FF2B5EF4-FFF2-40B4-BE49-F238E27FC236}">
                <a16:creationId xmlns:a16="http://schemas.microsoft.com/office/drawing/2014/main" id="{F5F117E7-8EAF-D7F2-38DC-0FC66E5CF881}"/>
              </a:ext>
            </a:extLst>
          </p:cNvPr>
          <p:cNvSpPr/>
          <p:nvPr/>
        </p:nvSpPr>
        <p:spPr>
          <a:xfrm>
            <a:off x="9802847" y="3718572"/>
            <a:ext cx="704922" cy="279542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/>
              <a:t>2017</a:t>
            </a:r>
          </a:p>
        </p:txBody>
      </p:sp>
      <p:sp>
        <p:nvSpPr>
          <p:cNvPr id="110" name="正方形/長方形 109">
            <a:extLst>
              <a:ext uri="{FF2B5EF4-FFF2-40B4-BE49-F238E27FC236}">
                <a16:creationId xmlns:a16="http://schemas.microsoft.com/office/drawing/2014/main" id="{A612D733-71D8-2266-2034-B275F30D88D7}"/>
              </a:ext>
            </a:extLst>
          </p:cNvPr>
          <p:cNvSpPr/>
          <p:nvPr/>
        </p:nvSpPr>
        <p:spPr>
          <a:xfrm>
            <a:off x="9802847" y="3998114"/>
            <a:ext cx="704922" cy="279542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/>
              <a:t>2018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618B865-0779-8AF6-9DBD-6AABC0C1AFF5}"/>
              </a:ext>
            </a:extLst>
          </p:cNvPr>
          <p:cNvSpPr txBox="1"/>
          <p:nvPr/>
        </p:nvSpPr>
        <p:spPr>
          <a:xfrm>
            <a:off x="7936172" y="8586"/>
            <a:ext cx="56853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solidFill>
                  <a:schemeClr val="accent3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F 3days</a:t>
            </a:r>
            <a:endParaRPr kumimoji="1" lang="ja-JP" altLang="en-US" sz="800" b="1">
              <a:solidFill>
                <a:schemeClr val="accent3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4CC4781-D24A-FD42-C524-3230E366F7CA}"/>
              </a:ext>
            </a:extLst>
          </p:cNvPr>
          <p:cNvSpPr txBox="1"/>
          <p:nvPr/>
        </p:nvSpPr>
        <p:spPr>
          <a:xfrm>
            <a:off x="7902862" y="1742443"/>
            <a:ext cx="56853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solidFill>
                  <a:schemeClr val="accent3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F 5days</a:t>
            </a:r>
            <a:endParaRPr kumimoji="1" lang="ja-JP" altLang="en-US" sz="800" b="1">
              <a:solidFill>
                <a:schemeClr val="accent3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84013B1-49AD-FAA4-1E54-B3D109414D07}"/>
              </a:ext>
            </a:extLst>
          </p:cNvPr>
          <p:cNvSpPr txBox="1"/>
          <p:nvPr/>
        </p:nvSpPr>
        <p:spPr>
          <a:xfrm>
            <a:off x="7879453" y="3487279"/>
            <a:ext cx="56853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solidFill>
                  <a:schemeClr val="accent3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F 7days</a:t>
            </a:r>
            <a:endParaRPr kumimoji="1" lang="ja-JP" altLang="en-US" sz="800" b="1">
              <a:solidFill>
                <a:schemeClr val="accent3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8B3E91D7-12F0-8625-DF35-9288E6E07AEC}"/>
              </a:ext>
            </a:extLst>
          </p:cNvPr>
          <p:cNvSpPr txBox="1"/>
          <p:nvPr/>
        </p:nvSpPr>
        <p:spPr>
          <a:xfrm>
            <a:off x="7928099" y="5227960"/>
            <a:ext cx="56853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solidFill>
                  <a:schemeClr val="accent3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F 9days</a:t>
            </a:r>
            <a:endParaRPr kumimoji="1" lang="ja-JP" altLang="en-US" sz="800" b="1">
              <a:solidFill>
                <a:schemeClr val="accent3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45587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E9EB445-C61C-17A5-69EB-6BFBAF07397E}"/>
              </a:ext>
            </a:extLst>
          </p:cNvPr>
          <p:cNvSpPr txBox="1"/>
          <p:nvPr/>
        </p:nvSpPr>
        <p:spPr>
          <a:xfrm>
            <a:off x="-4975" y="-435"/>
            <a:ext cx="12570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.</a:t>
            </a:r>
          </a:p>
          <a:p>
            <a:r>
              <a:rPr kumimoji="1" lang="en-US" altLang="ja-JP" dirty="0"/>
              <a:t>Figure S2.</a:t>
            </a:r>
            <a:endParaRPr kumimoji="1" lang="ja-JP" altLang="en-US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029B452A-4874-A529-9356-50C5969265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797" y="901700"/>
            <a:ext cx="3705173" cy="2223104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91B5DA2F-2BB8-3BE1-CF9F-21A4176C3E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96967" y="891408"/>
            <a:ext cx="3715465" cy="2233396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A1996504-662A-72AE-4C88-5097A783B2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70429" y="891408"/>
            <a:ext cx="3715465" cy="2233396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36C75ECC-6040-E525-62F1-21F797E2E1B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3797" y="3291104"/>
            <a:ext cx="3715465" cy="2233396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12E7D801-AF7E-271F-44C6-15F4A02F5A4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96967" y="3291104"/>
            <a:ext cx="3715465" cy="2233396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073580A0-6669-843C-B6C9-4A645356438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70429" y="3291104"/>
            <a:ext cx="3715465" cy="2233396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FDA7CBA-A7BE-CD3E-ECAE-67FCADE9F6A1}"/>
              </a:ext>
            </a:extLst>
          </p:cNvPr>
          <p:cNvSpPr txBox="1"/>
          <p:nvPr/>
        </p:nvSpPr>
        <p:spPr>
          <a:xfrm>
            <a:off x="606106" y="901700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u="sng" dirty="0"/>
              <a:t>2013</a:t>
            </a:r>
            <a:endParaRPr kumimoji="1" lang="ja-JP" altLang="en-US" u="sng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1EB257A-7403-24E7-1C83-FE98B01850F1}"/>
              </a:ext>
            </a:extLst>
          </p:cNvPr>
          <p:cNvSpPr txBox="1"/>
          <p:nvPr/>
        </p:nvSpPr>
        <p:spPr>
          <a:xfrm>
            <a:off x="4456705" y="908646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u="sng" dirty="0"/>
              <a:t>2014</a:t>
            </a:r>
            <a:endParaRPr kumimoji="1" lang="ja-JP" altLang="en-US" u="sng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8E99528-60F3-B590-71D3-97B710E2A7E1}"/>
              </a:ext>
            </a:extLst>
          </p:cNvPr>
          <p:cNvSpPr txBox="1"/>
          <p:nvPr/>
        </p:nvSpPr>
        <p:spPr>
          <a:xfrm>
            <a:off x="8348136" y="917222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u="sng" dirty="0"/>
              <a:t>2015</a:t>
            </a:r>
            <a:endParaRPr kumimoji="1" lang="ja-JP" altLang="en-US" u="sng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76EDFAA-B635-65F8-5BF6-61FE1549E74E}"/>
              </a:ext>
            </a:extLst>
          </p:cNvPr>
          <p:cNvSpPr txBox="1"/>
          <p:nvPr/>
        </p:nvSpPr>
        <p:spPr>
          <a:xfrm>
            <a:off x="606106" y="3258744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u="sng" dirty="0"/>
              <a:t>2016</a:t>
            </a:r>
            <a:endParaRPr kumimoji="1" lang="ja-JP" altLang="en-US" u="sng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0C18DE3-108D-082C-E690-961BE7B52C0C}"/>
              </a:ext>
            </a:extLst>
          </p:cNvPr>
          <p:cNvSpPr txBox="1"/>
          <p:nvPr/>
        </p:nvSpPr>
        <p:spPr>
          <a:xfrm>
            <a:off x="4456705" y="3264658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u="sng" dirty="0"/>
              <a:t>2017</a:t>
            </a:r>
            <a:endParaRPr kumimoji="1" lang="ja-JP" altLang="en-US" u="sng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E5BA1A6-3E72-D717-644E-DFB92589E932}"/>
              </a:ext>
            </a:extLst>
          </p:cNvPr>
          <p:cNvSpPr txBox="1"/>
          <p:nvPr/>
        </p:nvSpPr>
        <p:spPr>
          <a:xfrm>
            <a:off x="8343263" y="3298335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u="sng" dirty="0"/>
              <a:t>2018</a:t>
            </a:r>
            <a:endParaRPr kumimoji="1" lang="ja-JP" altLang="en-US" u="sng"/>
          </a:p>
        </p:txBody>
      </p:sp>
    </p:spTree>
    <p:extLst>
      <p:ext uri="{BB962C8B-B14F-4D97-AF65-F5344CB8AC3E}">
        <p14:creationId xmlns:p14="http://schemas.microsoft.com/office/powerpoint/2010/main" val="1428565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46A1E94-25BB-E976-8601-9FF7451FE93D}"/>
              </a:ext>
            </a:extLst>
          </p:cNvPr>
          <p:cNvSpPr txBox="1"/>
          <p:nvPr/>
        </p:nvSpPr>
        <p:spPr>
          <a:xfrm>
            <a:off x="-4975" y="-435"/>
            <a:ext cx="12570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.</a:t>
            </a:r>
          </a:p>
          <a:p>
            <a:r>
              <a:rPr kumimoji="1" lang="en-US" altLang="ja-JP" dirty="0"/>
              <a:t>Figure S3.</a:t>
            </a:r>
            <a:endParaRPr kumimoji="1" lang="ja-JP" altLang="en-US" dirty="0"/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E2659123-4D61-F700-7922-C5B80AE1A8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5062" y="910259"/>
            <a:ext cx="3642464" cy="2158876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84C9C27E-AF62-A02C-AB6E-5426A4BD355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67295" y="910259"/>
            <a:ext cx="3652696" cy="2158876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D06D3F77-781E-FCD6-A3F2-EA0942060B4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34474" y="910259"/>
            <a:ext cx="3642464" cy="2158876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56CE7F98-E9AB-3E34-F6E7-F872325A866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46525" y="3429000"/>
            <a:ext cx="3622001" cy="2158876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F914128B-3891-AEEF-DE3E-D1C9988CCAC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13242" y="3429000"/>
            <a:ext cx="3632233" cy="2158876"/>
          </a:xfrm>
          <a:prstGeom prst="rect">
            <a:avLst/>
          </a:prstGeom>
        </p:spPr>
      </p:pic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0297E3CB-E345-8451-E7F6-84217A44952A}"/>
              </a:ext>
            </a:extLst>
          </p:cNvPr>
          <p:cNvGrpSpPr/>
          <p:nvPr/>
        </p:nvGrpSpPr>
        <p:grpSpPr>
          <a:xfrm>
            <a:off x="890338" y="2838024"/>
            <a:ext cx="3188368" cy="165048"/>
            <a:chOff x="2088036" y="4088685"/>
            <a:chExt cx="3812568" cy="218200"/>
          </a:xfrm>
        </p:grpSpPr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5772F08D-902E-3ACB-E30D-92977D2ADB8E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3903171F-46FF-4340-F787-42D4C01EC810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5A46347F-06F1-DC28-5786-F38B1670419F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2768EDC2-8A9F-09FC-69F1-6EE242FA293C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EC9BC6ED-9880-0A32-2A49-12B8BC603272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EC1D4DBF-C00D-5B59-2D1E-5C23EBD9FD5C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7BF35B0F-97F2-97F8-6401-24AB70A84E7A}"/>
              </a:ext>
            </a:extLst>
          </p:cNvPr>
          <p:cNvGrpSpPr/>
          <p:nvPr/>
        </p:nvGrpSpPr>
        <p:grpSpPr>
          <a:xfrm>
            <a:off x="4650300" y="2798356"/>
            <a:ext cx="3188368" cy="165048"/>
            <a:chOff x="2088036" y="4088685"/>
            <a:chExt cx="3812568" cy="218200"/>
          </a:xfrm>
        </p:grpSpPr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050CC61B-10D6-E238-827D-1CA18770BBFB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DCFA0D09-7848-5082-C6C0-FE247AABF858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A8A156FB-955E-BA22-61F2-E69046FB749D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B02EAD91-BAAC-9334-1781-59BC5CA2A18C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BC50AB16-468F-A9EF-5100-4B3DCE10EAAC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DCD348A8-2949-BE5D-54D0-6060337D99D3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2C2A1F96-2B44-9663-C1C7-7B60479A2601}"/>
              </a:ext>
            </a:extLst>
          </p:cNvPr>
          <p:cNvGrpSpPr/>
          <p:nvPr/>
        </p:nvGrpSpPr>
        <p:grpSpPr>
          <a:xfrm>
            <a:off x="8417195" y="2803689"/>
            <a:ext cx="3188368" cy="165048"/>
            <a:chOff x="2088036" y="4088685"/>
            <a:chExt cx="3812568" cy="218200"/>
          </a:xfrm>
        </p:grpSpPr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8E89F271-72DB-DA0C-10BD-A98CA7B3AE4F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95683D69-98FB-47E7-8C24-A16FEBB428A4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79515208-36B4-82D2-69CB-C5C9112562B1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0ACAD18C-0E0B-1C70-506A-24A86F7BAAB7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0D2504E1-30F1-AADC-6FEE-0C574DE8C241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A5F9C2D5-2513-E642-E7AF-B6DE65EE126A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A9B5AF72-E824-F4F4-1C20-26198C411BB0}"/>
              </a:ext>
            </a:extLst>
          </p:cNvPr>
          <p:cNvGrpSpPr/>
          <p:nvPr/>
        </p:nvGrpSpPr>
        <p:grpSpPr>
          <a:xfrm>
            <a:off x="2723147" y="5361082"/>
            <a:ext cx="3160295" cy="165048"/>
            <a:chOff x="2088036" y="4088685"/>
            <a:chExt cx="3812568" cy="218200"/>
          </a:xfrm>
        </p:grpSpPr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B3A67E2E-F5CD-2291-2D85-773D9BD0EE1D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67DE8BD5-BDA1-2C79-4525-D46DEA131497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CAF98E5E-877C-861E-CE67-591CBBF44299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4FA43A0C-2373-1A6D-CC7A-6578AD8CC947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95118329-FE67-60CB-5BA8-D2CD67106564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39D8A5B1-D44F-145F-7245-3620C2958A83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53" name="グループ化 52">
            <a:extLst>
              <a:ext uri="{FF2B5EF4-FFF2-40B4-BE49-F238E27FC236}">
                <a16:creationId xmlns:a16="http://schemas.microsoft.com/office/drawing/2014/main" id="{964847AF-2D44-CDD2-5CD3-281B2FA54C89}"/>
              </a:ext>
            </a:extLst>
          </p:cNvPr>
          <p:cNvGrpSpPr/>
          <p:nvPr/>
        </p:nvGrpSpPr>
        <p:grpSpPr>
          <a:xfrm>
            <a:off x="6649085" y="5361082"/>
            <a:ext cx="3116547" cy="165048"/>
            <a:chOff x="2088036" y="4088685"/>
            <a:chExt cx="3812568" cy="218200"/>
          </a:xfrm>
        </p:grpSpPr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4DBED4C6-738F-4146-85EC-D0AB4C40E208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F36ED9E0-4C7A-69B6-5F6A-FB1A287392CD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AF457DA6-9A01-B284-9D2C-24B2AF3E3D5B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DC0D210D-3639-5278-659F-B115458E761C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18E3ACFC-2A24-712D-EF24-C698E3E3BFA1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419682CE-4CEB-663A-CB4C-6AA07F9BE849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</p:spTree>
    <p:extLst>
      <p:ext uri="{BB962C8B-B14F-4D97-AF65-F5344CB8AC3E}">
        <p14:creationId xmlns:p14="http://schemas.microsoft.com/office/powerpoint/2010/main" val="26631243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639B36D-3FDF-8DA3-192A-AA16EED5694C}"/>
              </a:ext>
            </a:extLst>
          </p:cNvPr>
          <p:cNvSpPr txBox="1"/>
          <p:nvPr/>
        </p:nvSpPr>
        <p:spPr>
          <a:xfrm>
            <a:off x="-4975" y="-435"/>
            <a:ext cx="12570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.</a:t>
            </a:r>
          </a:p>
          <a:p>
            <a:r>
              <a:rPr kumimoji="1" lang="en-US" altLang="ja-JP" dirty="0"/>
              <a:t>Figure S4.</a:t>
            </a:r>
            <a:endParaRPr kumimoji="1" lang="ja-JP" altLang="en-US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CE3E6A63-4211-E0D0-1152-620391D505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6822" y="859439"/>
            <a:ext cx="3572203" cy="2114987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826AD7D0-A0CB-95E6-BB4C-3BDF4BD4ED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70774" y="859439"/>
            <a:ext cx="3572203" cy="2114987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3C42D613-385C-3562-D11A-30389184D65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64726" y="859438"/>
            <a:ext cx="3622801" cy="2114987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A2C30F24-9C7B-9EE5-32DB-87F084F498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62923" y="3439119"/>
            <a:ext cx="3622800" cy="209474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D9F6B943-5D0E-E94A-1BA7-44B8CD00870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63445" y="3429000"/>
            <a:ext cx="3612681" cy="2104867"/>
          </a:xfrm>
          <a:prstGeom prst="rect">
            <a:avLst/>
          </a:prstGeom>
        </p:spPr>
      </p:pic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F5070819-F244-BBFE-3F79-69B63DBC80BE}"/>
              </a:ext>
            </a:extLst>
          </p:cNvPr>
          <p:cNvGrpSpPr/>
          <p:nvPr/>
        </p:nvGrpSpPr>
        <p:grpSpPr>
          <a:xfrm>
            <a:off x="1065494" y="2722410"/>
            <a:ext cx="3119125" cy="165048"/>
            <a:chOff x="2088036" y="4088685"/>
            <a:chExt cx="3812568" cy="218200"/>
          </a:xfrm>
        </p:grpSpPr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F30EDFA0-2E0E-3884-33D1-9346BBDE9838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A2DAF066-DEC3-935F-3EED-5CD66EEDAE8B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EED59E9A-B169-5120-3883-821DE3F0BE0E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ADBDD414-AE79-CB55-C5AA-04D2D3548569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69083D0B-057A-8BB4-9731-95A1EB9D1E4C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37107451-0B22-2808-5B5E-DBE764C46428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0FDA0FF2-1A11-4334-AA53-9ED9C15E2D7B}"/>
              </a:ext>
            </a:extLst>
          </p:cNvPr>
          <p:cNvGrpSpPr/>
          <p:nvPr/>
        </p:nvGrpSpPr>
        <p:grpSpPr>
          <a:xfrm>
            <a:off x="4924786" y="2722410"/>
            <a:ext cx="2953540" cy="165048"/>
            <a:chOff x="2088036" y="4088685"/>
            <a:chExt cx="3812568" cy="218200"/>
          </a:xfrm>
        </p:grpSpPr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960230E8-98A0-DB00-2448-533627050508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A543ECF0-A6B6-C719-620B-79FC60A93F7E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81EAE5D6-0C20-01CF-8BFA-D47F85AA09EF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0BF72311-EC36-A6FB-C6C2-B6DC0A2911EF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AFB755FF-DA38-7518-AB48-18963C48047F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DC8E7DE5-E598-C020-2788-9BFE02356F6C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9523F3B6-0484-D758-197B-8E2F8D88E88C}"/>
              </a:ext>
            </a:extLst>
          </p:cNvPr>
          <p:cNvGrpSpPr/>
          <p:nvPr/>
        </p:nvGrpSpPr>
        <p:grpSpPr>
          <a:xfrm>
            <a:off x="8614901" y="2722410"/>
            <a:ext cx="3015546" cy="165048"/>
            <a:chOff x="2088036" y="4088685"/>
            <a:chExt cx="3812568" cy="218200"/>
          </a:xfrm>
        </p:grpSpPr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D7DEFE31-8D91-FC22-3340-2AF69BF16F47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5B374671-81EC-4F3A-1929-22546D8CD9FF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12C1F410-26E7-99D2-5264-6E5B9ADE2FB8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969A3A22-EA3C-BEB6-6A95-7DE6BE0BC047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EFB33F19-3391-6C48-7529-730163BB9305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18C1EA96-B23C-7859-97B0-C196FB750C62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27F41A3C-9A33-BC58-F703-3BBEC2F39947}"/>
              </a:ext>
            </a:extLst>
          </p:cNvPr>
          <p:cNvGrpSpPr/>
          <p:nvPr/>
        </p:nvGrpSpPr>
        <p:grpSpPr>
          <a:xfrm>
            <a:off x="3017747" y="5315325"/>
            <a:ext cx="2995672" cy="165048"/>
            <a:chOff x="2088036" y="4088685"/>
            <a:chExt cx="3812568" cy="218200"/>
          </a:xfrm>
        </p:grpSpPr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3AC6F670-55B6-FD79-5316-978F295E3509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51652114-D825-F93E-DDB7-44E7F51F8976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EAB2610D-9E65-F2E2-10D0-29E0A9AD44F6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7713DEFD-AF85-714A-F176-C63B2EF09210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5F1B88A0-B407-5F95-CFE9-8177378E9386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83F94D6A-F069-EF29-7947-690326B82014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92D52031-8E73-29E4-A2E8-C92287AE1B5D}"/>
              </a:ext>
            </a:extLst>
          </p:cNvPr>
          <p:cNvGrpSpPr/>
          <p:nvPr/>
        </p:nvGrpSpPr>
        <p:grpSpPr>
          <a:xfrm>
            <a:off x="6820435" y="5315325"/>
            <a:ext cx="2999230" cy="165048"/>
            <a:chOff x="2088036" y="4088685"/>
            <a:chExt cx="3812568" cy="218200"/>
          </a:xfrm>
        </p:grpSpPr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5EBCA4B1-82AE-FF9B-B152-D02284824937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8F3C8A95-A917-FA10-8FD7-39794575BA21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0DBDCEB3-7CCA-1190-30DC-FC3BDDFD5FF4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B0FBFCCA-4834-79DA-605B-6ED0C1E6701A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229C50B1-636C-633E-0EAC-74303059CEC4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C7691EDB-25CC-3D27-9039-81C2A639BEB2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</p:spTree>
    <p:extLst>
      <p:ext uri="{BB962C8B-B14F-4D97-AF65-F5344CB8AC3E}">
        <p14:creationId xmlns:p14="http://schemas.microsoft.com/office/powerpoint/2010/main" val="16512252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C7F863A-164A-9186-3C29-9EEA7A2EE57A}"/>
              </a:ext>
            </a:extLst>
          </p:cNvPr>
          <p:cNvSpPr txBox="1"/>
          <p:nvPr/>
        </p:nvSpPr>
        <p:spPr>
          <a:xfrm>
            <a:off x="-4975" y="-435"/>
            <a:ext cx="12570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.</a:t>
            </a:r>
          </a:p>
          <a:p>
            <a:r>
              <a:rPr kumimoji="1" lang="en-US" altLang="ja-JP" dirty="0"/>
              <a:t>Figure S5.</a:t>
            </a:r>
            <a:endParaRPr kumimoji="1" lang="ja-JP" altLang="en-US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E9094F27-8D82-F03E-0D33-09F40CF857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5097" y="1192431"/>
            <a:ext cx="3749776" cy="2224443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48FD1C51-A0AA-0433-A2DC-559F1368DC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81496" y="1192430"/>
            <a:ext cx="3749776" cy="222444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B48A8D0A-A1D8-2744-34FF-A15F0F67A8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87895" y="1192432"/>
            <a:ext cx="3728590" cy="2224443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09186888-14B0-71A2-524E-595607E40B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83049" y="3609210"/>
            <a:ext cx="3717998" cy="217148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9E3D9C91-06E6-E603-05A6-07EFA3584E9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39430" y="3609210"/>
            <a:ext cx="3739183" cy="2171480"/>
          </a:xfrm>
          <a:prstGeom prst="rect">
            <a:avLst/>
          </a:prstGeom>
        </p:spPr>
      </p:pic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C7C0C976-4FE1-4807-19DC-937AB3B9CE1C}"/>
              </a:ext>
            </a:extLst>
          </p:cNvPr>
          <p:cNvGrpSpPr/>
          <p:nvPr/>
        </p:nvGrpSpPr>
        <p:grpSpPr>
          <a:xfrm>
            <a:off x="842658" y="3170634"/>
            <a:ext cx="3206823" cy="165048"/>
            <a:chOff x="2088036" y="4088685"/>
            <a:chExt cx="3812568" cy="218200"/>
          </a:xfrm>
        </p:grpSpPr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B9EF41FD-D1CD-320A-4320-DA0D0029701D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DF28B190-0DCA-A05E-D3EE-FCF1F0524813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18E7282B-F758-3362-2B79-95C39743F4C6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78B8957C-EF90-5F3D-C02D-245E96AC51E8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CF8FF435-9CE5-F87E-9EFE-ABE1D52CC3C8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F2654969-B317-D1CC-F8EC-B9EE1E65F9BC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49190BFC-5201-4170-056F-9CBA96EEFB19}"/>
              </a:ext>
            </a:extLst>
          </p:cNvPr>
          <p:cNvGrpSpPr/>
          <p:nvPr/>
        </p:nvGrpSpPr>
        <p:grpSpPr>
          <a:xfrm>
            <a:off x="4736907" y="3173462"/>
            <a:ext cx="3223500" cy="165048"/>
            <a:chOff x="2088036" y="4088685"/>
            <a:chExt cx="3812568" cy="218200"/>
          </a:xfrm>
        </p:grpSpPr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B6B2CF76-3712-7312-57FD-D39535E7F5D2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CF71B2A3-8B68-275E-82CD-65AA2D3922E3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E2B65845-A00C-71EE-8AA6-AF0DD94ED4F4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F38EDC99-2EE4-37A1-D7BD-E19CA2158A08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0583335E-FDF2-ECCB-0574-6A172249DA56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600AF4BE-EECA-3BF0-8421-081A4FFE2EF8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109AE31C-DDFF-4D5F-48A6-DD8A0BBA7D0C}"/>
              </a:ext>
            </a:extLst>
          </p:cNvPr>
          <p:cNvGrpSpPr/>
          <p:nvPr/>
        </p:nvGrpSpPr>
        <p:grpSpPr>
          <a:xfrm>
            <a:off x="8646503" y="3170634"/>
            <a:ext cx="3202241" cy="165048"/>
            <a:chOff x="2088036" y="4088685"/>
            <a:chExt cx="3812568" cy="218200"/>
          </a:xfrm>
        </p:grpSpPr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4ED7B1A3-06DC-4D38-A253-139E8E23E5B2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C44797AB-1DD6-B91A-A947-C07AD2C3D818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B0779987-66CA-9F1D-07EB-0A30E4111B67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6EA22650-E1DC-AFB0-5632-22D2D4020391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F27FAE20-3BFA-D861-F1CF-7C115669BB80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31F9D6ED-2A8D-0E12-E646-A51D4389D268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2DE5803E-BF72-28FE-1E5D-6730CF2763FD}"/>
              </a:ext>
            </a:extLst>
          </p:cNvPr>
          <p:cNvGrpSpPr/>
          <p:nvPr/>
        </p:nvGrpSpPr>
        <p:grpSpPr>
          <a:xfrm>
            <a:off x="2738920" y="5531907"/>
            <a:ext cx="3183316" cy="165048"/>
            <a:chOff x="2088036" y="4088685"/>
            <a:chExt cx="3812568" cy="218200"/>
          </a:xfrm>
        </p:grpSpPr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D321745F-97BB-55A8-7AAD-AE0FC983E58C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AD6459E5-F223-84AE-695D-2F7F28266D36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8DD233F0-F2E2-6C55-3E46-DA8FD96E9B2E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58F7D9B9-74D2-9EE7-1C15-96AA0D2EC333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3C920334-7773-8D01-79DF-C23C440EC8B7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327B7B32-DC44-753E-7BDA-5E2DC7D6B072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A51A95AB-7325-8947-8CB6-B002B635CED6}"/>
              </a:ext>
            </a:extLst>
          </p:cNvPr>
          <p:cNvGrpSpPr/>
          <p:nvPr/>
        </p:nvGrpSpPr>
        <p:grpSpPr>
          <a:xfrm>
            <a:off x="6695061" y="5531907"/>
            <a:ext cx="3213890" cy="165048"/>
            <a:chOff x="2088036" y="4088685"/>
            <a:chExt cx="3812568" cy="218200"/>
          </a:xfrm>
        </p:grpSpPr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98D4A247-FD5A-75C6-68DF-B7AB52699CF2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EAC8CB91-F26E-F930-6CDA-530183AFB880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918DF80F-403E-5B2F-493E-F27019798C35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A6592A79-E196-D128-3111-3721B61D665D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E4C2AB7D-9F71-43C9-845F-3E7C9472638F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73C4254D-BAD6-A6F5-9ADF-4FDCDBD88DA6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163B11C-9312-DAB0-338F-9FD482DA216D}"/>
              </a:ext>
            </a:extLst>
          </p:cNvPr>
          <p:cNvSpPr txBox="1"/>
          <p:nvPr/>
        </p:nvSpPr>
        <p:spPr>
          <a:xfrm>
            <a:off x="2002962" y="1203317"/>
            <a:ext cx="4940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accent3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F_1</a:t>
            </a:r>
            <a:endParaRPr kumimoji="1" lang="ja-JP" altLang="en-US" sz="1200">
              <a:solidFill>
                <a:schemeClr val="accent3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587B7A0-5F31-1473-E83F-DA0A6D3A6587}"/>
              </a:ext>
            </a:extLst>
          </p:cNvPr>
          <p:cNvSpPr txBox="1"/>
          <p:nvPr/>
        </p:nvSpPr>
        <p:spPr>
          <a:xfrm>
            <a:off x="5909361" y="1205296"/>
            <a:ext cx="4940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accent3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F_3</a:t>
            </a:r>
            <a:endParaRPr kumimoji="1" lang="ja-JP" altLang="en-US" sz="1200">
              <a:solidFill>
                <a:schemeClr val="accent3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C8ACED7-4626-8982-AA18-792EA722BCF4}"/>
              </a:ext>
            </a:extLst>
          </p:cNvPr>
          <p:cNvSpPr txBox="1"/>
          <p:nvPr/>
        </p:nvSpPr>
        <p:spPr>
          <a:xfrm>
            <a:off x="9805167" y="1203317"/>
            <a:ext cx="4940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accent3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F_5</a:t>
            </a:r>
            <a:endParaRPr kumimoji="1" lang="ja-JP" altLang="en-US" sz="1200">
              <a:solidFill>
                <a:schemeClr val="accent3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C751BA1E-13DA-46E0-4AEC-C09834BFA65C}"/>
              </a:ext>
            </a:extLst>
          </p:cNvPr>
          <p:cNvSpPr txBox="1"/>
          <p:nvPr/>
        </p:nvSpPr>
        <p:spPr>
          <a:xfrm>
            <a:off x="7861998" y="3616466"/>
            <a:ext cx="4940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accent3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F_9</a:t>
            </a:r>
            <a:endParaRPr kumimoji="1" lang="ja-JP" altLang="en-US" sz="1200">
              <a:solidFill>
                <a:schemeClr val="accent3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8976D50-D460-A05F-6283-27AFE76430D3}"/>
              </a:ext>
            </a:extLst>
          </p:cNvPr>
          <p:cNvSpPr txBox="1"/>
          <p:nvPr/>
        </p:nvSpPr>
        <p:spPr>
          <a:xfrm>
            <a:off x="3877850" y="3616465"/>
            <a:ext cx="49404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accent3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F_7</a:t>
            </a:r>
            <a:endParaRPr kumimoji="1" lang="ja-JP" altLang="en-US" sz="1200">
              <a:solidFill>
                <a:schemeClr val="accent3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18026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3F8A078-D915-8FC1-05D7-C3B138EA5E7E}"/>
              </a:ext>
            </a:extLst>
          </p:cNvPr>
          <p:cNvSpPr txBox="1"/>
          <p:nvPr/>
        </p:nvSpPr>
        <p:spPr>
          <a:xfrm>
            <a:off x="-4975" y="-435"/>
            <a:ext cx="12570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.</a:t>
            </a:r>
          </a:p>
          <a:p>
            <a:r>
              <a:rPr kumimoji="1" lang="en-US" altLang="ja-JP" dirty="0"/>
              <a:t>Figure S6.</a:t>
            </a:r>
            <a:endParaRPr kumimoji="1" lang="ja-JP" altLang="en-US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FEDB9C89-1556-0CD8-97A8-5418DF8390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9548" y="2089150"/>
            <a:ext cx="4495800" cy="26543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D17D37AB-ACE3-D7AC-FD42-D32D205187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6652" y="2101850"/>
            <a:ext cx="4495800" cy="2641600"/>
          </a:xfrm>
          <a:prstGeom prst="rect">
            <a:avLst/>
          </a:prstGeom>
        </p:spPr>
      </p:pic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D3789212-9CC9-8E35-21F3-E8E44DD930C6}"/>
              </a:ext>
            </a:extLst>
          </p:cNvPr>
          <p:cNvGrpSpPr/>
          <p:nvPr/>
        </p:nvGrpSpPr>
        <p:grpSpPr>
          <a:xfrm>
            <a:off x="2024505" y="4442386"/>
            <a:ext cx="3888615" cy="228088"/>
            <a:chOff x="2088036" y="4088685"/>
            <a:chExt cx="3812568" cy="218200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81446066-CEAB-8472-BE57-9B7CB312CB44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DACC7495-B4DC-8AC4-7251-0BF480F70583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86CA5674-24A1-F2E9-337C-5AD14604D82D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6A2302EB-5FB3-7434-12A8-26664DFB29D5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F2C93886-EBBF-E17F-34BE-5B6C1B63897F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9BA66120-FB56-1929-144E-67CE469A25D3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8BFF035E-BAE5-543E-8313-EB95612088EC}"/>
              </a:ext>
            </a:extLst>
          </p:cNvPr>
          <p:cNvGrpSpPr/>
          <p:nvPr/>
        </p:nvGrpSpPr>
        <p:grpSpPr>
          <a:xfrm>
            <a:off x="6671199" y="4442386"/>
            <a:ext cx="3917084" cy="228088"/>
            <a:chOff x="2088036" y="4088685"/>
            <a:chExt cx="3812568" cy="218200"/>
          </a:xfrm>
        </p:grpSpPr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5D9B88E4-1118-F24B-30ED-ED8EF06E673D}"/>
                </a:ext>
              </a:extLst>
            </p:cNvPr>
            <p:cNvSpPr>
              <a:spLocks/>
            </p:cNvSpPr>
            <p:nvPr/>
          </p:nvSpPr>
          <p:spPr>
            <a:xfrm>
              <a:off x="2088036" y="4088685"/>
              <a:ext cx="637226" cy="218200"/>
            </a:xfrm>
            <a:prstGeom prst="rect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3</a:t>
              </a:r>
              <a:endParaRPr kumimoji="1" lang="ja-JP" altLang="en-US" sz="1000" b="1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6ACFA2F2-B589-5D4A-C0C4-AAAFF5787D61}"/>
                </a:ext>
              </a:extLst>
            </p:cNvPr>
            <p:cNvSpPr>
              <a:spLocks/>
            </p:cNvSpPr>
            <p:nvPr/>
          </p:nvSpPr>
          <p:spPr>
            <a:xfrm>
              <a:off x="2723104" y="4088685"/>
              <a:ext cx="637226" cy="218200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4</a:t>
              </a:r>
              <a:endParaRPr kumimoji="1" lang="ja-JP" altLang="en-US" sz="1000" b="1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9CE0C081-4DA6-E710-446D-B8459A70C451}"/>
                </a:ext>
              </a:extLst>
            </p:cNvPr>
            <p:cNvSpPr>
              <a:spLocks/>
            </p:cNvSpPr>
            <p:nvPr/>
          </p:nvSpPr>
          <p:spPr>
            <a:xfrm>
              <a:off x="3358172" y="4088685"/>
              <a:ext cx="637226" cy="218200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5</a:t>
              </a:r>
              <a:endParaRPr kumimoji="1" lang="ja-JP" altLang="en-US" sz="1000" b="1"/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36FE35C8-84FB-EC6F-B7FF-A2447B096F92}"/>
                </a:ext>
              </a:extLst>
            </p:cNvPr>
            <p:cNvSpPr>
              <a:spLocks/>
            </p:cNvSpPr>
            <p:nvPr/>
          </p:nvSpPr>
          <p:spPr>
            <a:xfrm>
              <a:off x="3993240" y="4088685"/>
              <a:ext cx="637226" cy="218200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6</a:t>
              </a:r>
              <a:endParaRPr kumimoji="1" lang="ja-JP" altLang="en-US" sz="1000" b="1"/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6C39B382-E190-7A73-36C5-E9369A70499D}"/>
                </a:ext>
              </a:extLst>
            </p:cNvPr>
            <p:cNvSpPr>
              <a:spLocks/>
            </p:cNvSpPr>
            <p:nvPr/>
          </p:nvSpPr>
          <p:spPr>
            <a:xfrm>
              <a:off x="4628308" y="4088685"/>
              <a:ext cx="637226" cy="21820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7</a:t>
              </a:r>
              <a:endParaRPr kumimoji="1" lang="ja-JP" altLang="en-US" sz="1000" b="1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FA5DC69D-CC78-802D-C503-1185EECC88C9}"/>
                </a:ext>
              </a:extLst>
            </p:cNvPr>
            <p:cNvSpPr>
              <a:spLocks/>
            </p:cNvSpPr>
            <p:nvPr/>
          </p:nvSpPr>
          <p:spPr>
            <a:xfrm>
              <a:off x="5263378" y="4088685"/>
              <a:ext cx="637226" cy="218200"/>
            </a:xfrm>
            <a:prstGeom prst="rect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b="1" dirty="0"/>
                <a:t>2018</a:t>
              </a:r>
              <a:endParaRPr kumimoji="1" lang="ja-JP" altLang="en-US" sz="1000" b="1"/>
            </a:p>
          </p:txBody>
        </p:sp>
      </p:grpSp>
    </p:spTree>
    <p:extLst>
      <p:ext uri="{BB962C8B-B14F-4D97-AF65-F5344CB8AC3E}">
        <p14:creationId xmlns:p14="http://schemas.microsoft.com/office/powerpoint/2010/main" val="12839635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831F4B8-11D1-C930-B2F4-F85BCE091947}"/>
              </a:ext>
            </a:extLst>
          </p:cNvPr>
          <p:cNvSpPr txBox="1"/>
          <p:nvPr/>
        </p:nvSpPr>
        <p:spPr>
          <a:xfrm>
            <a:off x="-4975" y="-435"/>
            <a:ext cx="12570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.</a:t>
            </a:r>
          </a:p>
          <a:p>
            <a:r>
              <a:rPr kumimoji="1" lang="en-US" altLang="ja-JP" dirty="0"/>
              <a:t>Figure S7.</a:t>
            </a:r>
            <a:endParaRPr kumimoji="1" lang="ja-JP" altLang="en-US" dirty="0"/>
          </a:p>
        </p:txBody>
      </p:sp>
      <p:pic>
        <p:nvPicPr>
          <p:cNvPr id="4" name="図 3" descr="グラフ, 散布図&#10;&#10;自動的に生成された説明">
            <a:extLst>
              <a:ext uri="{FF2B5EF4-FFF2-40B4-BE49-F238E27FC236}">
                <a16:creationId xmlns:a16="http://schemas.microsoft.com/office/drawing/2014/main" id="{9D47965A-DC78-DE12-02A7-C8F1899CDF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8375" y="0"/>
            <a:ext cx="771525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7618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44</TotalTime>
  <Words>177</Words>
  <Application>Microsoft Office PowerPoint</Application>
  <PresentationFormat>Widescreen</PresentationFormat>
  <Paragraphs>142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游ゴシック</vt:lpstr>
      <vt:lpstr>游ゴシック Light</vt:lpstr>
      <vt:lpstr>Arial</vt:lpstr>
      <vt:lpstr>Calibri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及川</dc:creator>
  <cp:lastModifiedBy>MDPI</cp:lastModifiedBy>
  <cp:revision>35</cp:revision>
  <dcterms:created xsi:type="dcterms:W3CDTF">2023-08-31T08:03:08Z</dcterms:created>
  <dcterms:modified xsi:type="dcterms:W3CDTF">2023-12-27T06:52:07Z</dcterms:modified>
</cp:coreProperties>
</file>